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DE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20" d="100"/>
          <a:sy n="20" d="100"/>
        </p:scale>
        <p:origin x="2784" y="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194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757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485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592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42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07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456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18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093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33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ED8868-ADCD-4DCF-84EB-4E613DA77A3A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70A3C7-52AF-461C-B1DF-68B73D129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185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>
            <a:extLst>
              <a:ext uri="{FF2B5EF4-FFF2-40B4-BE49-F238E27FC236}">
                <a16:creationId xmlns:a16="http://schemas.microsoft.com/office/drawing/2014/main" id="{54F20509-51C2-FDF0-DE94-A23A7B2D5E98}"/>
              </a:ext>
            </a:extLst>
          </p:cNvPr>
          <p:cNvSpPr txBox="1"/>
          <p:nvPr/>
        </p:nvSpPr>
        <p:spPr>
          <a:xfrm>
            <a:off x="74285" y="7310166"/>
            <a:ext cx="670943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Vehicle controls (0.01% DMSO, 24% BSA, and media only) do not alter inflammatory, mitochondrial, or oxidative parameters in THP-1-derived macrophag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IL-1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evels in cell culture supernatants assessed by ELISA reveal no significant changes across vehicle controls. (B) JC-1 assay quantifying mitochondrial membrane potential shows no significant difference in aggregate-to-monomer fluorescence ratio among 0.01% DMSO, 24% BSA, or media alone (C) Mea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urecenc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sity of JC-1 monomers (MFI) . (D) Intracellular ROS production measured by DCFH-DA flow cytometry also shows no difference among vehicle groups. Positive control (200 µM H₂O₂) induces a marked increase in ROS, validating the assay sensitivity.(E) Overlay histograms represent fluorescence distribution for DCFH-DA in the indicated groups. Data represent n = 3; ns = not significant (ANOVA).</a:t>
            </a:r>
          </a:p>
        </p:txBody>
      </p:sp>
      <p:grpSp>
        <p:nvGrpSpPr>
          <p:cNvPr id="77" name="Group 76">
            <a:extLst>
              <a:ext uri="{FF2B5EF4-FFF2-40B4-BE49-F238E27FC236}">
                <a16:creationId xmlns:a16="http://schemas.microsoft.com/office/drawing/2014/main" id="{9626C66E-4449-826D-40D7-C5C3ACB15665}"/>
              </a:ext>
            </a:extLst>
          </p:cNvPr>
          <p:cNvGrpSpPr/>
          <p:nvPr/>
        </p:nvGrpSpPr>
        <p:grpSpPr>
          <a:xfrm>
            <a:off x="3967" y="103829"/>
            <a:ext cx="6638608" cy="7573583"/>
            <a:chOff x="3967" y="103829"/>
            <a:chExt cx="6638608" cy="7573583"/>
          </a:xfrm>
        </p:grpSpPr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218E969C-928C-8655-181F-E2D8A99ED1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84872681"/>
                </p:ext>
              </p:extLst>
            </p:nvPr>
          </p:nvGraphicFramePr>
          <p:xfrm>
            <a:off x="297617" y="4424624"/>
            <a:ext cx="2998788" cy="32527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998850" imgH="3252666" progId="Prism10.Document">
                    <p:embed/>
                  </p:oleObj>
                </mc:Choice>
                <mc:Fallback>
                  <p:oleObj name="Prism 10" r:id="rId2" imgW="2998850" imgH="3252666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97617" y="4424624"/>
                          <a:ext cx="2998788" cy="32527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74E5A32F-4D21-049F-BD1A-FB3B2635A3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47542958"/>
                </p:ext>
              </p:extLst>
            </p:nvPr>
          </p:nvGraphicFramePr>
          <p:xfrm>
            <a:off x="2122961" y="288495"/>
            <a:ext cx="2244725" cy="367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244006" imgH="3679322" progId="Prism10.Document">
                    <p:embed/>
                  </p:oleObj>
                </mc:Choice>
                <mc:Fallback>
                  <p:oleObj name="Prism 10" r:id="rId4" imgW="2244006" imgH="3679322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22961" y="288495"/>
                          <a:ext cx="2244725" cy="367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12764466-77B9-3FEF-3EF2-51E0B599032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42945805"/>
                </p:ext>
              </p:extLst>
            </p:nvPr>
          </p:nvGraphicFramePr>
          <p:xfrm>
            <a:off x="176406" y="495519"/>
            <a:ext cx="2057400" cy="3448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056735" imgH="3447811" progId="Prism10.Document">
                    <p:embed/>
                  </p:oleObj>
                </mc:Choice>
                <mc:Fallback>
                  <p:oleObj name="Prism 10" r:id="rId6" imgW="2056735" imgH="3447811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76406" y="495519"/>
                          <a:ext cx="2057400" cy="3448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0EC2C3D-92B2-140B-B5CE-5852E8E2F55D}"/>
                </a:ext>
              </a:extLst>
            </p:cNvPr>
            <p:cNvSpPr txBox="1"/>
            <p:nvPr/>
          </p:nvSpPr>
          <p:spPr>
            <a:xfrm>
              <a:off x="3967" y="10382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9E5B00A-2D9A-9A88-40F8-9EC921191038}"/>
                </a:ext>
              </a:extLst>
            </p:cNvPr>
            <p:cNvSpPr txBox="1"/>
            <p:nvPr/>
          </p:nvSpPr>
          <p:spPr>
            <a:xfrm>
              <a:off x="1947272" y="10382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5072E9F-F151-EE9C-8E15-51AD2CE24CC8}"/>
                </a:ext>
              </a:extLst>
            </p:cNvPr>
            <p:cNvSpPr txBox="1"/>
            <p:nvPr/>
          </p:nvSpPr>
          <p:spPr>
            <a:xfrm>
              <a:off x="92156" y="414743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994D2F4-8253-A2A5-6F1E-ED56E17CB7AD}"/>
                </a:ext>
              </a:extLst>
            </p:cNvPr>
            <p:cNvSpPr txBox="1"/>
            <p:nvPr/>
          </p:nvSpPr>
          <p:spPr>
            <a:xfrm>
              <a:off x="4228410" y="11016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8D0484A-A84A-C908-F857-6D1026A69206}"/>
                </a:ext>
              </a:extLst>
            </p:cNvPr>
            <p:cNvSpPr txBox="1"/>
            <p:nvPr/>
          </p:nvSpPr>
          <p:spPr>
            <a:xfrm>
              <a:off x="3192500" y="411406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9B21C6CB-9E2D-2200-7F4A-97F2542DFDD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08530" y="610341"/>
              <a:ext cx="2434045" cy="2518953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6FDEFA01-CC8E-0781-03F2-0A13821FA86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561597" y="4187246"/>
              <a:ext cx="2680945" cy="28267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82332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</TotalTime>
  <Words>170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Fatema Alrashed</dc:creator>
  <cp:lastModifiedBy>Dr. Fatema Alrashed</cp:lastModifiedBy>
  <cp:revision>5</cp:revision>
  <dcterms:created xsi:type="dcterms:W3CDTF">2025-04-17T04:47:38Z</dcterms:created>
  <dcterms:modified xsi:type="dcterms:W3CDTF">2025-04-24T12:26:08Z</dcterms:modified>
</cp:coreProperties>
</file>